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93" d="100"/>
          <a:sy n="93" d="100"/>
        </p:scale>
        <p:origin x="211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CoQ10\PCSK9%20CoQ1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CoQ10\PCSK9%20CoQ10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ayato\Desktop\CoQ10\PCSK9%20CoQ10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8.7149444444444446E-2"/>
                  <c:y val="-8.9490058479532161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Sheet1!$A$2:$A$11</c:f>
              <c:numCache>
                <c:formatCode>General</c:formatCode>
                <c:ptCount val="10"/>
                <c:pt idx="0">
                  <c:v>-66.666666666666671</c:v>
                </c:pt>
                <c:pt idx="1">
                  <c:v>-46.031746031746032</c:v>
                </c:pt>
                <c:pt idx="2">
                  <c:v>-54.081632653061227</c:v>
                </c:pt>
                <c:pt idx="3">
                  <c:v>-54.477611940298509</c:v>
                </c:pt>
                <c:pt idx="4">
                  <c:v>-45.528455284552848</c:v>
                </c:pt>
                <c:pt idx="5">
                  <c:v>-53.793103448275865</c:v>
                </c:pt>
                <c:pt idx="6">
                  <c:v>-55.102040816326529</c:v>
                </c:pt>
                <c:pt idx="7">
                  <c:v>-46.218487394957982</c:v>
                </c:pt>
                <c:pt idx="8">
                  <c:v>-43.75</c:v>
                </c:pt>
                <c:pt idx="9">
                  <c:v>-42.727272727272727</c:v>
                </c:pt>
              </c:numCache>
            </c:numRef>
          </c:xVal>
          <c:yVal>
            <c:numRef>
              <c:f>Sheet1!$B$2:$B$11</c:f>
              <c:numCache>
                <c:formatCode>General</c:formatCode>
                <c:ptCount val="10"/>
                <c:pt idx="0">
                  <c:v>-35.149469623915145</c:v>
                </c:pt>
                <c:pt idx="1">
                  <c:v>-18.248175182481752</c:v>
                </c:pt>
                <c:pt idx="2">
                  <c:v>-5.3571428571428541</c:v>
                </c:pt>
                <c:pt idx="3">
                  <c:v>2.8846153846153744</c:v>
                </c:pt>
                <c:pt idx="4">
                  <c:v>-40.394973070017954</c:v>
                </c:pt>
                <c:pt idx="5">
                  <c:v>-24.019138755980858</c:v>
                </c:pt>
                <c:pt idx="6">
                  <c:v>-26.086956521739136</c:v>
                </c:pt>
                <c:pt idx="7">
                  <c:v>-50.854700854700845</c:v>
                </c:pt>
                <c:pt idx="8">
                  <c:v>-23.221936589545852</c:v>
                </c:pt>
                <c:pt idx="9">
                  <c:v>-6.066945606694559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3B7-42D0-962D-64A4D46421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37249791"/>
        <c:axId val="737254111"/>
      </c:scatterChart>
      <c:valAx>
        <c:axId val="737249791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737254111"/>
        <c:crosses val="autoZero"/>
        <c:crossBetween val="midCat"/>
      </c:valAx>
      <c:valAx>
        <c:axId val="737254111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73724979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7.0586388888888893E-2"/>
                  <c:y val="0.17628888888888888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Sheet1!$A$2:$A$11</c:f>
              <c:numCache>
                <c:formatCode>General</c:formatCode>
                <c:ptCount val="10"/>
                <c:pt idx="0">
                  <c:v>-66.666666666666671</c:v>
                </c:pt>
                <c:pt idx="1">
                  <c:v>-46.031746031746032</c:v>
                </c:pt>
                <c:pt idx="2">
                  <c:v>-54.081632653061227</c:v>
                </c:pt>
                <c:pt idx="3">
                  <c:v>-54.477611940298509</c:v>
                </c:pt>
                <c:pt idx="4">
                  <c:v>-45.528455284552848</c:v>
                </c:pt>
                <c:pt idx="5">
                  <c:v>-53.793103448275865</c:v>
                </c:pt>
                <c:pt idx="6">
                  <c:v>-55.102040816326529</c:v>
                </c:pt>
                <c:pt idx="7">
                  <c:v>-46.218487394957982</c:v>
                </c:pt>
                <c:pt idx="8">
                  <c:v>-43.75</c:v>
                </c:pt>
                <c:pt idx="9">
                  <c:v>-42.727272727272727</c:v>
                </c:pt>
              </c:numCache>
            </c:numRef>
          </c:xVal>
          <c:yVal>
            <c:numRef>
              <c:f>Sheet1!$C$2:$C$11</c:f>
              <c:numCache>
                <c:formatCode>General</c:formatCode>
                <c:ptCount val="10"/>
                <c:pt idx="0">
                  <c:v>-0.67114093959731547</c:v>
                </c:pt>
                <c:pt idx="1">
                  <c:v>-2.674230145867099</c:v>
                </c:pt>
                <c:pt idx="2">
                  <c:v>0.52910052910052907</c:v>
                </c:pt>
                <c:pt idx="3">
                  <c:v>4.8888888888888893</c:v>
                </c:pt>
                <c:pt idx="4">
                  <c:v>5.5555555555555554</c:v>
                </c:pt>
                <c:pt idx="5">
                  <c:v>-16.949152542372882</c:v>
                </c:pt>
                <c:pt idx="6">
                  <c:v>0.303951367781155</c:v>
                </c:pt>
                <c:pt idx="7">
                  <c:v>-5.9044048734770387</c:v>
                </c:pt>
                <c:pt idx="8">
                  <c:v>-1.2858555885262117</c:v>
                </c:pt>
                <c:pt idx="9">
                  <c:v>2.56147540983606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BF4-461F-B690-A846FD1173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37264671"/>
        <c:axId val="737271391"/>
      </c:scatterChart>
      <c:valAx>
        <c:axId val="737264671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737271391"/>
        <c:crosses val="autoZero"/>
        <c:crossBetween val="midCat"/>
      </c:valAx>
      <c:valAx>
        <c:axId val="73727139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73726467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4721638888888889"/>
                  <c:y val="0.24091812865497075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Calibri" panose="020F0502020204030204" pitchFamily="34" charset="0"/>
                    </a:defRPr>
                  </a:pPr>
                  <a:endParaRPr lang="ja-JP"/>
                </a:p>
              </c:txPr>
            </c:trendlineLbl>
          </c:trendline>
          <c:xVal>
            <c:numRef>
              <c:f>Sheet1!$B$2:$B$11</c:f>
              <c:numCache>
                <c:formatCode>General</c:formatCode>
                <c:ptCount val="10"/>
                <c:pt idx="0">
                  <c:v>-35.149469623915145</c:v>
                </c:pt>
                <c:pt idx="1">
                  <c:v>-18.248175182481752</c:v>
                </c:pt>
                <c:pt idx="2">
                  <c:v>-5.3571428571428541</c:v>
                </c:pt>
                <c:pt idx="3">
                  <c:v>2.8846153846153744</c:v>
                </c:pt>
                <c:pt idx="4">
                  <c:v>-40.394973070017954</c:v>
                </c:pt>
                <c:pt idx="5">
                  <c:v>-24.019138755980858</c:v>
                </c:pt>
                <c:pt idx="6">
                  <c:v>-26.086956521739136</c:v>
                </c:pt>
                <c:pt idx="7">
                  <c:v>-50.854700854700845</c:v>
                </c:pt>
                <c:pt idx="8">
                  <c:v>-23.221936589545852</c:v>
                </c:pt>
                <c:pt idx="9">
                  <c:v>-6.0669456066945591</c:v>
                </c:pt>
              </c:numCache>
            </c:numRef>
          </c:xVal>
          <c:yVal>
            <c:numRef>
              <c:f>Sheet1!$C$2:$C$11</c:f>
              <c:numCache>
                <c:formatCode>General</c:formatCode>
                <c:ptCount val="10"/>
                <c:pt idx="0">
                  <c:v>-0.67114093959731547</c:v>
                </c:pt>
                <c:pt idx="1">
                  <c:v>-2.674230145867099</c:v>
                </c:pt>
                <c:pt idx="2">
                  <c:v>0.52910052910052907</c:v>
                </c:pt>
                <c:pt idx="3">
                  <c:v>4.8888888888888893</c:v>
                </c:pt>
                <c:pt idx="4">
                  <c:v>5.5555555555555554</c:v>
                </c:pt>
                <c:pt idx="5">
                  <c:v>-16.949152542372882</c:v>
                </c:pt>
                <c:pt idx="6">
                  <c:v>0.303951367781155</c:v>
                </c:pt>
                <c:pt idx="7">
                  <c:v>-5.9044048734770387</c:v>
                </c:pt>
                <c:pt idx="8">
                  <c:v>-1.2858555885262117</c:v>
                </c:pt>
                <c:pt idx="9">
                  <c:v>2.561475409836065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586-41E1-BF96-865CFCFAB0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1647967"/>
        <c:axId val="741646527"/>
      </c:scatterChart>
      <c:valAx>
        <c:axId val="741647967"/>
        <c:scaling>
          <c:orientation val="minMax"/>
        </c:scaling>
        <c:delete val="1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741646527"/>
        <c:crosses val="autoZero"/>
        <c:crossBetween val="midCat"/>
      </c:valAx>
      <c:valAx>
        <c:axId val="741646527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741647967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035485-2629-3222-4A14-5793C869C5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F991B3-4E0B-E712-A411-07ED1871E2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94AF11-F02A-F2B4-0BAD-9CE7757722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C9548-EB50-48F7-AA17-5680BFF87EC8}" type="datetimeFigureOut">
              <a:rPr kumimoji="1" lang="ja-JP" altLang="en-US" smtClean="0"/>
              <a:t>2026/4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B9567A-1C53-91DA-F197-3750A0E1D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65FF2C-4D4C-3519-0E9F-DC548CE50E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E955-BD0B-4F1B-AB17-90684A17E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9304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311174-8329-96AC-C887-707BC9BC1B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BD54AF0-CCEA-506E-891A-8AAA35B913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ED8185-093C-F122-358A-3D53BAC566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C9548-EB50-48F7-AA17-5680BFF87EC8}" type="datetimeFigureOut">
              <a:rPr kumimoji="1" lang="ja-JP" altLang="en-US" smtClean="0"/>
              <a:t>2026/4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AB039AC-83A8-0F3B-8703-262E1B917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F176E78-182A-9E8B-14AB-ECCE106C9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E955-BD0B-4F1B-AB17-90684A17E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90439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884526E-E752-0B49-246F-B5F5FA5F83C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BFDF6A7-80AF-A78A-9FB3-943645F48D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FAB8471-ED14-AC26-E98B-0443CBE8E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C9548-EB50-48F7-AA17-5680BFF87EC8}" type="datetimeFigureOut">
              <a:rPr kumimoji="1" lang="ja-JP" altLang="en-US" smtClean="0"/>
              <a:t>2026/4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FA6AC9-BFCE-B4CB-8AE5-E1C5EC82C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80541D1-1962-5B3C-32A9-B80064A3B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E955-BD0B-4F1B-AB17-90684A17E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33472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BF9C79D-9A8E-9743-DEB9-F931DFE84A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5BFF9AE-0EFE-A4CA-270D-A204424868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5B98FE7-084A-7861-A626-97E2996BBF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C9548-EB50-48F7-AA17-5680BFF87EC8}" type="datetimeFigureOut">
              <a:rPr kumimoji="1" lang="ja-JP" altLang="en-US" smtClean="0"/>
              <a:t>2026/4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647597-C77C-B2DC-2690-CD9BB3CF9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712ED74-C2A5-90A4-F8F7-692F70C43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E955-BD0B-4F1B-AB17-90684A17E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9104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252D9F-8951-8C79-A761-9AF322C9FB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19EE055-8AF8-19FE-5357-58DE4D85C8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28054C6-2420-5B79-9972-B2A84861A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C9548-EB50-48F7-AA17-5680BFF87EC8}" type="datetimeFigureOut">
              <a:rPr kumimoji="1" lang="ja-JP" altLang="en-US" smtClean="0"/>
              <a:t>2026/4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D6969C8-77C2-8C56-1969-470664F32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C764CE2-6EA8-C690-8FAF-2CB3AD4453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E955-BD0B-4F1B-AB17-90684A17E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4554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5E7C34-D2C5-2CA1-6E36-A96ADB4A1B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BE11A24-410B-5A8E-28F0-837ECE138D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D2273A6-1281-D895-C04D-7554D971FF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7A0C1B1-0269-1DFD-3966-C4DD8D0779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C9548-EB50-48F7-AA17-5680BFF87EC8}" type="datetimeFigureOut">
              <a:rPr kumimoji="1" lang="ja-JP" altLang="en-US" smtClean="0"/>
              <a:t>2026/4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2A93E2E-2874-6293-F687-95831ADC0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F42440A-526D-CFDA-BDED-9AC11731AC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E955-BD0B-4F1B-AB17-90684A17E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270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FF7236-76BA-640D-FA04-9D375CDE52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65FE495-7920-C4AF-EA77-36A63E1A85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AB34248-0F07-856F-A666-0201C6205B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693666A-6B20-80DF-23D3-F69EE9B737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3524CF1-BE5E-88E9-D18D-8B342514DF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C42B546-16FC-CDB7-AC40-079DDA669E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C9548-EB50-48F7-AA17-5680BFF87EC8}" type="datetimeFigureOut">
              <a:rPr kumimoji="1" lang="ja-JP" altLang="en-US" smtClean="0"/>
              <a:t>2026/4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B5267B0-1FD7-DBC1-6D60-C38FE9AD5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632B449-4AAF-D3CC-EDAA-16A2814A9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E955-BD0B-4F1B-AB17-90684A17E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01077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AD7596-A7F5-D796-8354-BF0359A516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41356CA-86CC-FE11-D0D6-CBE8C8F7F9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C9548-EB50-48F7-AA17-5680BFF87EC8}" type="datetimeFigureOut">
              <a:rPr kumimoji="1" lang="ja-JP" altLang="en-US" smtClean="0"/>
              <a:t>2026/4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3028E80-60A7-F6CF-5DC6-C014C27DF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E4D5D1E-21AB-FCCD-FC98-8220F5BBB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E955-BD0B-4F1B-AB17-90684A17E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381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6B0779A-CF62-C2E0-03E3-25F422B281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C9548-EB50-48F7-AA17-5680BFF87EC8}" type="datetimeFigureOut">
              <a:rPr kumimoji="1" lang="ja-JP" altLang="en-US" smtClean="0"/>
              <a:t>2026/4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B1FC543-EBB3-BBC2-D28C-3CBDDF0B1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F457F53-6403-C94C-FAAE-C78633C2C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E955-BD0B-4F1B-AB17-90684A17E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90506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764FF0-F4BB-2F29-297C-533B7EC48A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E02C955-A8A3-D5D7-359C-59498A4BD5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0AD2009-213D-D6D6-3198-27B1673DFC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F4BFD5C-EC8A-A865-B215-3AE367FD7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C9548-EB50-48F7-AA17-5680BFF87EC8}" type="datetimeFigureOut">
              <a:rPr kumimoji="1" lang="ja-JP" altLang="en-US" smtClean="0"/>
              <a:t>2026/4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D9AD5D6-E74E-5CCF-ECAC-0298E2F57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5B596B2-EB41-2D1C-9CE7-9818586314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E955-BD0B-4F1B-AB17-90684A17E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0080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6B4436F-A0A4-5845-CBE3-F4FA1EE9AE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EAA43A7-8805-11BA-5C35-FF3301CE18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831654B-754F-E8A1-3D2E-FDE7717461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9A31E7-BEAA-AE7B-3B70-C2A00D9E8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C9548-EB50-48F7-AA17-5680BFF87EC8}" type="datetimeFigureOut">
              <a:rPr kumimoji="1" lang="ja-JP" altLang="en-US" smtClean="0"/>
              <a:t>2026/4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C4A68B7-6AB5-8477-0213-8CF873683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D333322-1D01-8227-CE61-B9D74B067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E955-BD0B-4F1B-AB17-90684A17E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97312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CA414CE-4877-D22E-F960-EC59D1F2B3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6890982-C1CA-D09B-9224-D7C3705AAD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44374A-C51C-0DCB-03E5-8DEFA9E9B1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C9548-EB50-48F7-AA17-5680BFF87EC8}" type="datetimeFigureOut">
              <a:rPr kumimoji="1" lang="ja-JP" altLang="en-US" smtClean="0"/>
              <a:t>2026/4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20BEDBE-DB68-80C1-3148-23AC8A623C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1E59534-07E1-FD01-C55C-A9A9C0BA7B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0E955-BD0B-4F1B-AB17-90684A17E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9326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97DDE226-ACF7-96C4-EBEF-94321FD66F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9058365"/>
              </p:ext>
            </p:extLst>
          </p:nvPr>
        </p:nvGraphicFramePr>
        <p:xfrm>
          <a:off x="514869" y="1579606"/>
          <a:ext cx="3600000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125072C3-D906-5406-E366-B1A2B270EA0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2832207"/>
              </p:ext>
            </p:extLst>
          </p:nvPr>
        </p:nvGraphicFramePr>
        <p:xfrm>
          <a:off x="4491084" y="1626974"/>
          <a:ext cx="3600000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2182D1A8-6B43-5EAD-C385-A76040BDEBE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96995616"/>
              </p:ext>
            </p:extLst>
          </p:nvPr>
        </p:nvGraphicFramePr>
        <p:xfrm>
          <a:off x="8483848" y="1669606"/>
          <a:ext cx="3600000" cy="34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DB437C0-0A66-FBB9-63BC-A177A7F4014E}"/>
              </a:ext>
            </a:extLst>
          </p:cNvPr>
          <p:cNvSpPr txBox="1"/>
          <p:nvPr/>
        </p:nvSpPr>
        <p:spPr>
          <a:xfrm rot="16200000">
            <a:off x="-1078481" y="3182691"/>
            <a:ext cx="25051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cent c</a:t>
            </a: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ange of </a:t>
            </a:r>
            <a:r>
              <a:rPr kumimoji="1" lang="en-US" altLang="ja-JP" sz="16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p</a:t>
            </a: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a) (%)</a:t>
            </a:r>
            <a:endParaRPr kumimoji="1" lang="ja-JP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2193443-3F34-FA18-F85C-62A3A802F7FC}"/>
              </a:ext>
            </a:extLst>
          </p:cNvPr>
          <p:cNvSpPr txBox="1"/>
          <p:nvPr/>
        </p:nvSpPr>
        <p:spPr>
          <a:xfrm>
            <a:off x="574511" y="5221301"/>
            <a:ext cx="33698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cent c</a:t>
            </a: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ange of LDL cholesterol (%)</a:t>
            </a:r>
            <a:endParaRPr kumimoji="1" lang="ja-JP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EEC537D-9A2E-A3E9-29E8-777732BC91F4}"/>
              </a:ext>
            </a:extLst>
          </p:cNvPr>
          <p:cNvSpPr txBox="1"/>
          <p:nvPr/>
        </p:nvSpPr>
        <p:spPr>
          <a:xfrm rot="16200000">
            <a:off x="2918501" y="3120329"/>
            <a:ext cx="2647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cent c</a:t>
            </a: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ange of CoQ10 (%)</a:t>
            </a:r>
            <a:endParaRPr kumimoji="1" lang="ja-JP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F7F204F-4C6B-3F6F-7CC3-9E637FC6DE67}"/>
              </a:ext>
            </a:extLst>
          </p:cNvPr>
          <p:cNvSpPr txBox="1"/>
          <p:nvPr/>
        </p:nvSpPr>
        <p:spPr>
          <a:xfrm>
            <a:off x="4495675" y="5221301"/>
            <a:ext cx="33698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cent c</a:t>
            </a: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ange of LDL cholesterol (%)</a:t>
            </a:r>
            <a:endParaRPr kumimoji="1" lang="ja-JP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DACFDC5-0E79-4E3B-58D8-740675BAC96E}"/>
              </a:ext>
            </a:extLst>
          </p:cNvPr>
          <p:cNvSpPr txBox="1"/>
          <p:nvPr/>
        </p:nvSpPr>
        <p:spPr>
          <a:xfrm rot="16200000">
            <a:off x="6904326" y="3325624"/>
            <a:ext cx="26477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cent c</a:t>
            </a: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ange of CoQ10 (%)</a:t>
            </a:r>
            <a:endParaRPr kumimoji="1" lang="ja-JP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4BE103F-AFE5-464C-6DF7-9F1D8FD48571}"/>
              </a:ext>
            </a:extLst>
          </p:cNvPr>
          <p:cNvSpPr txBox="1"/>
          <p:nvPr/>
        </p:nvSpPr>
        <p:spPr>
          <a:xfrm>
            <a:off x="8798481" y="5221301"/>
            <a:ext cx="25051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cent c</a:t>
            </a: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ange of </a:t>
            </a:r>
            <a:r>
              <a:rPr kumimoji="1" lang="en-US" altLang="ja-JP" sz="1600" b="1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p</a:t>
            </a:r>
            <a:r>
              <a:rPr kumimoji="1" lang="en-US" altLang="ja-JP" sz="16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a) (%)</a:t>
            </a:r>
            <a:endParaRPr kumimoji="1" lang="ja-JP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2760CE4-BE34-7A6A-E929-C98F8FAA326F}"/>
              </a:ext>
            </a:extLst>
          </p:cNvPr>
          <p:cNvSpPr txBox="1"/>
          <p:nvPr/>
        </p:nvSpPr>
        <p:spPr>
          <a:xfrm>
            <a:off x="268085" y="1585632"/>
            <a:ext cx="421910" cy="33840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spcBef>
                <a:spcPts val="1800"/>
              </a:spcBef>
            </a:pP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</a:t>
            </a:r>
          </a:p>
          <a:p>
            <a:pPr algn="r">
              <a:spcBef>
                <a:spcPts val="1800"/>
              </a:spcBef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</a:t>
            </a:r>
          </a:p>
          <a:p>
            <a:pPr algn="r">
              <a:spcBef>
                <a:spcPts val="1800"/>
              </a:spcBef>
            </a:pP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10</a:t>
            </a:r>
          </a:p>
          <a:p>
            <a:pPr algn="r">
              <a:spcBef>
                <a:spcPts val="1800"/>
              </a:spcBef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20</a:t>
            </a:r>
          </a:p>
          <a:p>
            <a:pPr algn="r">
              <a:spcBef>
                <a:spcPts val="1800"/>
              </a:spcBef>
            </a:pP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30</a:t>
            </a:r>
          </a:p>
          <a:p>
            <a:pPr algn="r">
              <a:spcBef>
                <a:spcPts val="1800"/>
              </a:spcBef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40</a:t>
            </a:r>
          </a:p>
          <a:p>
            <a:pPr algn="r">
              <a:spcBef>
                <a:spcPts val="1800"/>
              </a:spcBef>
            </a:pP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50</a:t>
            </a:r>
          </a:p>
          <a:p>
            <a:pPr algn="r">
              <a:spcBef>
                <a:spcPts val="1800"/>
              </a:spcBef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60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B58F235-70E3-8A1C-242A-75BD024836B9}"/>
              </a:ext>
            </a:extLst>
          </p:cNvPr>
          <p:cNvSpPr txBox="1"/>
          <p:nvPr/>
        </p:nvSpPr>
        <p:spPr>
          <a:xfrm>
            <a:off x="427687" y="4859444"/>
            <a:ext cx="3669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spcBef>
                <a:spcPts val="600"/>
              </a:spcBef>
            </a:pP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80              -60               -40                -20                0</a:t>
            </a:r>
            <a:endParaRPr lang="en-US" altLang="ja-JP" sz="14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8F8BF4B-DF07-4C72-A24E-6D34620F6FA1}"/>
              </a:ext>
            </a:extLst>
          </p:cNvPr>
          <p:cNvSpPr txBox="1"/>
          <p:nvPr/>
        </p:nvSpPr>
        <p:spPr>
          <a:xfrm>
            <a:off x="4245977" y="1628419"/>
            <a:ext cx="421910" cy="34470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spcBef>
                <a:spcPts val="2400"/>
              </a:spcBef>
            </a:pP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</a:t>
            </a:r>
          </a:p>
          <a:p>
            <a:pPr algn="r">
              <a:spcBef>
                <a:spcPts val="2400"/>
              </a:spcBef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</a:t>
            </a:r>
          </a:p>
          <a:p>
            <a:pPr algn="r">
              <a:spcBef>
                <a:spcPts val="2400"/>
              </a:spcBef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</a:t>
            </a:r>
          </a:p>
          <a:p>
            <a:pPr algn="r">
              <a:spcBef>
                <a:spcPts val="2400"/>
              </a:spcBef>
            </a:pP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5</a:t>
            </a:r>
          </a:p>
          <a:p>
            <a:pPr algn="r">
              <a:spcBef>
                <a:spcPts val="2400"/>
              </a:spcBef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10</a:t>
            </a:r>
          </a:p>
          <a:p>
            <a:pPr algn="r">
              <a:spcBef>
                <a:spcPts val="2400"/>
              </a:spcBef>
            </a:pP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15</a:t>
            </a:r>
          </a:p>
          <a:p>
            <a:pPr algn="r">
              <a:spcBef>
                <a:spcPts val="2400"/>
              </a:spcBef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20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F4C717B-D0F2-948F-687C-72EA638F0576}"/>
              </a:ext>
            </a:extLst>
          </p:cNvPr>
          <p:cNvSpPr txBox="1"/>
          <p:nvPr/>
        </p:nvSpPr>
        <p:spPr>
          <a:xfrm>
            <a:off x="8186457" y="1656057"/>
            <a:ext cx="421910" cy="34470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spcBef>
                <a:spcPts val="2400"/>
              </a:spcBef>
            </a:pP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</a:t>
            </a:r>
          </a:p>
          <a:p>
            <a:pPr algn="r">
              <a:spcBef>
                <a:spcPts val="2400"/>
              </a:spcBef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</a:t>
            </a:r>
          </a:p>
          <a:p>
            <a:pPr algn="r">
              <a:spcBef>
                <a:spcPts val="2400"/>
              </a:spcBef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</a:t>
            </a:r>
          </a:p>
          <a:p>
            <a:pPr algn="r">
              <a:spcBef>
                <a:spcPts val="2400"/>
              </a:spcBef>
            </a:pP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5</a:t>
            </a:r>
          </a:p>
          <a:p>
            <a:pPr algn="r">
              <a:spcBef>
                <a:spcPts val="2400"/>
              </a:spcBef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10</a:t>
            </a:r>
          </a:p>
          <a:p>
            <a:pPr algn="r">
              <a:spcBef>
                <a:spcPts val="2400"/>
              </a:spcBef>
            </a:pP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15</a:t>
            </a:r>
          </a:p>
          <a:p>
            <a:pPr algn="r">
              <a:spcBef>
                <a:spcPts val="2400"/>
              </a:spcBef>
            </a:pPr>
            <a:r>
              <a:rPr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20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2B5FFB2C-1A7F-D040-847E-1BD45DDDC757}"/>
              </a:ext>
            </a:extLst>
          </p:cNvPr>
          <p:cNvSpPr txBox="1"/>
          <p:nvPr/>
        </p:nvSpPr>
        <p:spPr>
          <a:xfrm>
            <a:off x="8405177" y="4970110"/>
            <a:ext cx="37257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spcBef>
                <a:spcPts val="600"/>
              </a:spcBef>
            </a:pP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60     -50      -40      -30      -20      -10         0        10</a:t>
            </a:r>
            <a:endParaRPr lang="en-US" altLang="ja-JP" sz="14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0BAB8C2-BDAF-983C-49A2-FF20B80EAE91}"/>
              </a:ext>
            </a:extLst>
          </p:cNvPr>
          <p:cNvSpPr txBox="1"/>
          <p:nvPr/>
        </p:nvSpPr>
        <p:spPr>
          <a:xfrm>
            <a:off x="4427937" y="4904010"/>
            <a:ext cx="3669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spcBef>
                <a:spcPts val="600"/>
              </a:spcBef>
            </a:pPr>
            <a:r>
              <a:rPr kumimoji="1" lang="en-US" altLang="ja-JP" sz="1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80              -60               -40                -20                0</a:t>
            </a:r>
            <a:endParaRPr lang="en-US" altLang="ja-JP" sz="14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5C9B63B-45E6-70A1-5F49-E25743633CFC}"/>
              </a:ext>
            </a:extLst>
          </p:cNvPr>
          <p:cNvSpPr txBox="1"/>
          <p:nvPr/>
        </p:nvSpPr>
        <p:spPr>
          <a:xfrm>
            <a:off x="106021" y="99856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ADC95FF-21DC-4A50-5498-C5DB607538F2}"/>
              </a:ext>
            </a:extLst>
          </p:cNvPr>
          <p:cNvSpPr txBox="1"/>
          <p:nvPr/>
        </p:nvSpPr>
        <p:spPr>
          <a:xfrm>
            <a:off x="4193297" y="99856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7C1D417-9B67-60D5-88F0-F7F18E6D4462}"/>
              </a:ext>
            </a:extLst>
          </p:cNvPr>
          <p:cNvSpPr txBox="1"/>
          <p:nvPr/>
        </p:nvSpPr>
        <p:spPr>
          <a:xfrm>
            <a:off x="8175096" y="99856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F78B5A7-5B58-D29B-DCAE-023FF9AEEC3C}"/>
              </a:ext>
            </a:extLst>
          </p:cNvPr>
          <p:cNvSpPr txBox="1"/>
          <p:nvPr/>
        </p:nvSpPr>
        <p:spPr>
          <a:xfrm>
            <a:off x="2033715" y="167213"/>
            <a:ext cx="714306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1</a:t>
            </a:r>
            <a:r>
              <a:rPr lang="en-US" altLang="ja-JP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Correlations between changes of lipids and CoQ10</a:t>
            </a:r>
            <a:endParaRPr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84815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120</Words>
  <Application>Microsoft Office PowerPoint</Application>
  <PresentationFormat>ワイド画面</PresentationFormat>
  <Paragraphs>3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隼人 多田</dc:creator>
  <cp:lastModifiedBy>隼人 多田</cp:lastModifiedBy>
  <cp:revision>22</cp:revision>
  <dcterms:created xsi:type="dcterms:W3CDTF">2025-10-03T00:37:21Z</dcterms:created>
  <dcterms:modified xsi:type="dcterms:W3CDTF">2026-04-30T10:24:24Z</dcterms:modified>
</cp:coreProperties>
</file>